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56" r:id="rId1"/>
  </p:sldMasterIdLst>
  <p:notesMasterIdLst>
    <p:notesMasterId r:id="rId11"/>
  </p:notes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  <p:sldId id="266" r:id="rId9"/>
    <p:sldId id="268" r:id="rId10"/>
  </p:sldIdLst>
  <p:sldSz cx="6858000" cy="9906000" type="A4"/>
  <p:notesSz cx="6858000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19" userDrawn="1">
          <p15:clr>
            <a:srgbClr val="A4A3A4"/>
          </p15:clr>
        </p15:guide>
        <p15:guide id="2" pos="216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lmos, Manuel" initials="OM" lastIdx="17" clrIdx="0">
    <p:extLst>
      <p:ext uri="{19B8F6BF-5375-455C-9EA6-DF929625EA0E}">
        <p15:presenceInfo xmlns:p15="http://schemas.microsoft.com/office/powerpoint/2012/main" userId="S-1-5-21-1015157209-3483221682-2525886298-9754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761AB"/>
    <a:srgbClr val="00A579"/>
    <a:srgbClr val="00B0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814"/>
    <p:restoredTop sz="94698"/>
  </p:normalViewPr>
  <p:slideViewPr>
    <p:cSldViewPr snapToGrid="0" snapToObjects="1">
      <p:cViewPr varScale="1">
        <p:scale>
          <a:sx n="122" d="100"/>
          <a:sy n="122" d="100"/>
        </p:scale>
        <p:origin x="3630" y="120"/>
      </p:cViewPr>
      <p:guideLst>
        <p:guide orient="horz" pos="3119"/>
        <p:guide pos="216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45FEE9-3B55-4AD4-A51D-FF5C268014F3}" type="datetimeFigureOut">
              <a:rPr lang="de-DE" smtClean="0"/>
              <a:t>22.05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70125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77194"/>
            <a:ext cx="548640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584"/>
            <a:ext cx="2971800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53A7EC-466D-4C26-ADB3-25FDD995363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90390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1pPr>
    <a:lvl2pPr marL="173243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2pPr>
    <a:lvl3pPr marL="346487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3pPr>
    <a:lvl4pPr marL="519730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4pPr>
    <a:lvl5pPr marL="692974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5pPr>
    <a:lvl6pPr marL="866217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6pPr>
    <a:lvl7pPr marL="1039460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7pPr>
    <a:lvl8pPr marL="1212703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8pPr>
    <a:lvl9pPr marL="1385946" algn="l" defTabSz="346487" rtl="0" eaLnBrk="1" latinLnBrk="0" hangingPunct="1">
      <a:defRPr sz="45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93108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46702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02003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64088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21678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02372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454632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54437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4541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97596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76130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A4F05-CBD8-2448-A903-B01B026E97F4}" type="datetimeFigureOut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22.05.2025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2BE7DE-9C7E-C544-AFE2-E6EB0D69000A}" type="slidenum">
              <a:rPr lang="de-DE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de-DE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274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2.png"/><Relationship Id="rId7" Type="http://schemas.openxmlformats.org/officeDocument/2006/relationships/image" Target="../media/image23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13.png"/><Relationship Id="rId10" Type="http://schemas.openxmlformats.org/officeDocument/2006/relationships/image" Target="../media/image26.png"/><Relationship Id="rId4" Type="http://schemas.openxmlformats.org/officeDocument/2006/relationships/image" Target="../media/image21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png"/><Relationship Id="rId3" Type="http://schemas.openxmlformats.org/officeDocument/2006/relationships/image" Target="../media/image38.png"/><Relationship Id="rId7" Type="http://schemas.openxmlformats.org/officeDocument/2006/relationships/image" Target="../media/image42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1.png"/><Relationship Id="rId11" Type="http://schemas.openxmlformats.org/officeDocument/2006/relationships/image" Target="../media/image46.png"/><Relationship Id="rId5" Type="http://schemas.openxmlformats.org/officeDocument/2006/relationships/image" Target="../media/image40.png"/><Relationship Id="rId10" Type="http://schemas.openxmlformats.org/officeDocument/2006/relationships/image" Target="../media/image45.png"/><Relationship Id="rId4" Type="http://schemas.openxmlformats.org/officeDocument/2006/relationships/image" Target="../media/image39.png"/><Relationship Id="rId9" Type="http://schemas.openxmlformats.org/officeDocument/2006/relationships/image" Target="../media/image4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38.png"/><Relationship Id="rId7" Type="http://schemas.openxmlformats.org/officeDocument/2006/relationships/image" Target="../media/image5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0" Type="http://schemas.openxmlformats.org/officeDocument/2006/relationships/image" Target="../media/image53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0.png"/><Relationship Id="rId3" Type="http://schemas.openxmlformats.org/officeDocument/2006/relationships/image" Target="../media/image56.png"/><Relationship Id="rId7" Type="http://schemas.openxmlformats.org/officeDocument/2006/relationships/image" Target="../media/image59.png"/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8.png"/><Relationship Id="rId5" Type="http://schemas.openxmlformats.org/officeDocument/2006/relationships/image" Target="../media/image57.png"/><Relationship Id="rId4" Type="http://schemas.openxmlformats.org/officeDocument/2006/relationships/image" Target="../media/image20.png"/><Relationship Id="rId9" Type="http://schemas.openxmlformats.org/officeDocument/2006/relationships/image" Target="../media/image61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68.png"/><Relationship Id="rId3" Type="http://schemas.openxmlformats.org/officeDocument/2006/relationships/image" Target="../media/image63.png"/><Relationship Id="rId7" Type="http://schemas.openxmlformats.org/officeDocument/2006/relationships/image" Target="../media/image67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6.png"/><Relationship Id="rId11" Type="http://schemas.openxmlformats.org/officeDocument/2006/relationships/image" Target="../media/image71.png"/><Relationship Id="rId5" Type="http://schemas.openxmlformats.org/officeDocument/2006/relationships/image" Target="../media/image65.png"/><Relationship Id="rId10" Type="http://schemas.openxmlformats.org/officeDocument/2006/relationships/image" Target="../media/image70.png"/><Relationship Id="rId4" Type="http://schemas.openxmlformats.org/officeDocument/2006/relationships/image" Target="../media/image64.png"/><Relationship Id="rId9" Type="http://schemas.openxmlformats.org/officeDocument/2006/relationships/image" Target="../media/image69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76.png"/><Relationship Id="rId3" Type="http://schemas.openxmlformats.org/officeDocument/2006/relationships/image" Target="../media/image13.png"/><Relationship Id="rId7" Type="http://schemas.openxmlformats.org/officeDocument/2006/relationships/image" Target="../media/image75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4.png"/><Relationship Id="rId11" Type="http://schemas.openxmlformats.org/officeDocument/2006/relationships/image" Target="../media/image79.png"/><Relationship Id="rId5" Type="http://schemas.openxmlformats.org/officeDocument/2006/relationships/image" Target="../media/image73.png"/><Relationship Id="rId10" Type="http://schemas.openxmlformats.org/officeDocument/2006/relationships/image" Target="../media/image78.png"/><Relationship Id="rId4" Type="http://schemas.openxmlformats.org/officeDocument/2006/relationships/image" Target="../media/image14.png"/><Relationship Id="rId9" Type="http://schemas.openxmlformats.org/officeDocument/2006/relationships/image" Target="../media/image7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211BBF52-BEA5-46CC-9940-1F348019EB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15325" y="912681"/>
            <a:ext cx="2920327" cy="148195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85F337E-039C-46E5-841A-7AE3954485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8911" y="917174"/>
            <a:ext cx="2920327" cy="148195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31510C17-0ADC-469B-9E23-D72E83EEF968}"/>
              </a:ext>
            </a:extLst>
          </p:cNvPr>
          <p:cNvSpPr txBox="1"/>
          <p:nvPr/>
        </p:nvSpPr>
        <p:spPr>
          <a:xfrm>
            <a:off x="2886326" y="314245"/>
            <a:ext cx="10769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istances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18D1A1D1-CC65-4B5A-A596-44F89362102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8911" y="2529384"/>
            <a:ext cx="2920327" cy="1481957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7F409222-E9B4-4908-AC98-F085608230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5325" y="2529384"/>
            <a:ext cx="2920327" cy="1481957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9036C1A8-B25F-4C3F-AFA1-79F9E9DCA5F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15325" y="4141594"/>
            <a:ext cx="2920327" cy="1481957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8AFA4A95-0192-47DE-87A9-1F9C1A3FE02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8911" y="5753804"/>
            <a:ext cx="2920327" cy="1481957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BD24D95E-E819-4D1B-9BD3-DD14A85EFA8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15325" y="5753804"/>
            <a:ext cx="2920327" cy="1481957"/>
          </a:xfrm>
          <a:prstGeom prst="rect">
            <a:avLst/>
          </a:prstGeom>
        </p:spPr>
      </p:pic>
      <p:pic>
        <p:nvPicPr>
          <p:cNvPr id="32" name="Grafik 31">
            <a:extLst>
              <a:ext uri="{FF2B5EF4-FFF2-40B4-BE49-F238E27FC236}">
                <a16:creationId xmlns:a16="http://schemas.microsoft.com/office/drawing/2014/main" id="{45B5C853-00DD-4246-931A-4E472EF6B7D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8911" y="7366014"/>
            <a:ext cx="2920327" cy="1481957"/>
          </a:xfrm>
          <a:prstGeom prst="rect">
            <a:avLst/>
          </a:prstGeom>
        </p:spPr>
      </p:pic>
      <p:pic>
        <p:nvPicPr>
          <p:cNvPr id="34" name="Grafik 33">
            <a:extLst>
              <a:ext uri="{FF2B5EF4-FFF2-40B4-BE49-F238E27FC236}">
                <a16:creationId xmlns:a16="http://schemas.microsoft.com/office/drawing/2014/main" id="{80000A7A-895E-4F9F-97F5-9F91281F6DB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15324" y="7366014"/>
            <a:ext cx="2920327" cy="1481957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F03E91DB-5BE0-43A8-BDE9-DD749B73BFF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8627" y="4146087"/>
            <a:ext cx="2920373" cy="14184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6305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E11A439A-47DC-4F46-95CF-954040E83A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2517" y="917175"/>
            <a:ext cx="2920327" cy="1481957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91CCAF46-81B5-4543-949C-DD5DC7C77B9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954" y="917175"/>
            <a:ext cx="2920327" cy="148195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E03297BF-BE2D-4492-B984-25122D910CF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954" y="2565965"/>
            <a:ext cx="2931223" cy="1481957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47540981-9E40-4146-9EC7-9742651E4D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2517" y="2565965"/>
            <a:ext cx="2920327" cy="1481957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A98B1346-A346-45D4-9B2B-AFFFE0232A4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954" y="4214755"/>
            <a:ext cx="2920327" cy="1481957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A3F5D964-77E7-44D4-A62F-216F132CC98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2517" y="4214755"/>
            <a:ext cx="2920327" cy="1481957"/>
          </a:xfrm>
          <a:prstGeom prst="rect">
            <a:avLst/>
          </a:prstGeom>
        </p:spPr>
      </p:pic>
      <p:pic>
        <p:nvPicPr>
          <p:cNvPr id="22" name="Grafik 21">
            <a:extLst>
              <a:ext uri="{FF2B5EF4-FFF2-40B4-BE49-F238E27FC236}">
                <a16:creationId xmlns:a16="http://schemas.microsoft.com/office/drawing/2014/main" id="{08D82FF7-81D6-42FC-AA6E-25A6DEF4483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0585" y="5858079"/>
            <a:ext cx="2931223" cy="1481957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1BA728A7-DA97-4748-9C0B-8EA7664AB72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2517" y="5858079"/>
            <a:ext cx="2931223" cy="1481957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F851ED0F-D9C7-47F8-AD6B-238AACC08B0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0585" y="7501403"/>
            <a:ext cx="2931592" cy="1482143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B39A2293-2271-44B3-85B8-7FC59DE633D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02517" y="7501403"/>
            <a:ext cx="2931223" cy="1481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06668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12" name="Grafik 11">
            <a:extLst>
              <a:ext uri="{FF2B5EF4-FFF2-40B4-BE49-F238E27FC236}">
                <a16:creationId xmlns:a16="http://schemas.microsoft.com/office/drawing/2014/main" id="{E828F5B0-0C08-44E2-8C12-EDD10ED6D9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2517" y="917175"/>
            <a:ext cx="2920327" cy="1481957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2EA7B086-D6E6-411E-82E8-A5E23824A4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954" y="917175"/>
            <a:ext cx="2920327" cy="148195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8E8761FC-227B-4B5B-83DB-9A12CB4400C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0954" y="2587721"/>
            <a:ext cx="2931224" cy="1481957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E3B97183-983C-416C-B533-9B24C6D9416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2517" y="2587721"/>
            <a:ext cx="2931224" cy="1481957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0667D38D-2B42-426F-A4C8-5E6EA522DE8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0954" y="4258267"/>
            <a:ext cx="2931224" cy="1481957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8BE5CE37-025A-4930-8DCC-A4B28A555D3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2517" y="4258267"/>
            <a:ext cx="2931224" cy="1481957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B1187D08-E58A-43C1-9EA4-D02327D73D1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0954" y="5927655"/>
            <a:ext cx="2918046" cy="1480799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FE6BA248-81D4-4DC7-B289-3A8E6E81BAA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2517" y="5928813"/>
            <a:ext cx="2931224" cy="1481957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F71C5B24-8978-4188-BEA9-ADC7AA98EF7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0067" y="7598201"/>
            <a:ext cx="2928933" cy="1480799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904417AB-45E6-4FA4-B7E3-DDA727F83CD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02517" y="7598201"/>
            <a:ext cx="2918045" cy="1480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28124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>
            <a:extLst>
              <a:ext uri="{FF2B5EF4-FFF2-40B4-BE49-F238E27FC236}">
                <a16:creationId xmlns:a16="http://schemas.microsoft.com/office/drawing/2014/main" id="{010856A8-15A1-4886-AB5B-FB645AA730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935" y="2587721"/>
            <a:ext cx="2925065" cy="1484361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AFBC9C59-30D2-4F48-B5E2-6082DA406F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2517" y="917175"/>
            <a:ext cx="2931224" cy="1487487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47C46683-97DD-4258-B2C5-D03A57933E6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935" y="917175"/>
            <a:ext cx="2927346" cy="1485519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23" name="Grafik 22">
            <a:extLst>
              <a:ext uri="{FF2B5EF4-FFF2-40B4-BE49-F238E27FC236}">
                <a16:creationId xmlns:a16="http://schemas.microsoft.com/office/drawing/2014/main" id="{E707929B-B42B-4765-9FEE-C4143C5B4FD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2517" y="2587721"/>
            <a:ext cx="2925064" cy="1484361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E38F53A1-7734-4EED-BAB1-F22A927BAAB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935" y="4255141"/>
            <a:ext cx="2925065" cy="1484361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B41294F6-8645-4894-B015-F5B5BB27B6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04411" y="8196037"/>
            <a:ext cx="2935978" cy="1484361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F4E7B254-FE3A-4B35-B4A3-766D2EC5440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2993" y="6525489"/>
            <a:ext cx="2925064" cy="1478843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C7208BA5-96B5-468D-BABE-166070550C1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03935" y="6525489"/>
            <a:ext cx="2935978" cy="1484361"/>
          </a:xfrm>
          <a:prstGeom prst="rect">
            <a:avLst/>
          </a:prstGeom>
        </p:spPr>
      </p:pic>
      <p:sp>
        <p:nvSpPr>
          <p:cNvPr id="30" name="Textfeld 29">
            <a:extLst>
              <a:ext uri="{FF2B5EF4-FFF2-40B4-BE49-F238E27FC236}">
                <a16:creationId xmlns:a16="http://schemas.microsoft.com/office/drawing/2014/main" id="{7C3988B9-2621-4D27-99B8-2F416958584F}"/>
              </a:ext>
            </a:extLst>
          </p:cNvPr>
          <p:cNvSpPr txBox="1"/>
          <p:nvPr/>
        </p:nvSpPr>
        <p:spPr>
          <a:xfrm>
            <a:off x="2657373" y="5922561"/>
            <a:ext cx="15442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rface curves</a:t>
            </a:r>
          </a:p>
        </p:txBody>
      </p:sp>
      <p:pic>
        <p:nvPicPr>
          <p:cNvPr id="31" name="Grafik 30">
            <a:extLst>
              <a:ext uri="{FF2B5EF4-FFF2-40B4-BE49-F238E27FC236}">
                <a16:creationId xmlns:a16="http://schemas.microsoft.com/office/drawing/2014/main" id="{D0C4D761-5BE4-4143-B9EB-F45D3351556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02993" y="8196036"/>
            <a:ext cx="2935979" cy="14843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77805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Grafik 37">
            <a:extLst>
              <a:ext uri="{FF2B5EF4-FFF2-40B4-BE49-F238E27FC236}">
                <a16:creationId xmlns:a16="http://schemas.microsoft.com/office/drawing/2014/main" id="{7E660681-04E5-406A-B309-69BE523C7D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8684" y="4057725"/>
            <a:ext cx="2941668" cy="1492787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5D5E023E-9DC7-4728-B170-7D8FCAB287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793" y="738763"/>
            <a:ext cx="2935978" cy="1484361"/>
          </a:xfrm>
          <a:prstGeom prst="rect">
            <a:avLst/>
          </a:prstGeom>
        </p:spPr>
      </p:pic>
      <p:pic>
        <p:nvPicPr>
          <p:cNvPr id="40" name="Grafik 39">
            <a:extLst>
              <a:ext uri="{FF2B5EF4-FFF2-40B4-BE49-F238E27FC236}">
                <a16:creationId xmlns:a16="http://schemas.microsoft.com/office/drawing/2014/main" id="{EEA29DA1-7264-4826-AD8C-B2CE0A44F0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9160" y="738763"/>
            <a:ext cx="2925064" cy="1484361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id="{5AD43F71-ED36-4918-B44B-2908581EC0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6269" y="2409311"/>
            <a:ext cx="2935502" cy="1489658"/>
          </a:xfrm>
          <a:prstGeom prst="rect">
            <a:avLst/>
          </a:prstGeom>
        </p:spPr>
      </p:pic>
      <p:pic>
        <p:nvPicPr>
          <p:cNvPr id="42" name="Grafik 41">
            <a:extLst>
              <a:ext uri="{FF2B5EF4-FFF2-40B4-BE49-F238E27FC236}">
                <a16:creationId xmlns:a16="http://schemas.microsoft.com/office/drawing/2014/main" id="{46D73521-7578-443B-983F-C5ACF728263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9160" y="2409311"/>
            <a:ext cx="2946456" cy="1489658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D65A4746-BCCA-4583-92F0-F4B76FCE76B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6269" y="4057725"/>
            <a:ext cx="2941669" cy="149278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44" name="Grafik 43">
            <a:extLst>
              <a:ext uri="{FF2B5EF4-FFF2-40B4-BE49-F238E27FC236}">
                <a16:creationId xmlns:a16="http://schemas.microsoft.com/office/drawing/2014/main" id="{2682B30A-E401-429B-B9FD-EE900135AD3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8684" y="7353398"/>
            <a:ext cx="2925064" cy="1484361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F69C7B33-617C-4355-91EB-53E9804292B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31970" y="7379815"/>
            <a:ext cx="2935978" cy="1484361"/>
          </a:xfrm>
          <a:prstGeom prst="rect">
            <a:avLst/>
          </a:prstGeom>
        </p:spPr>
      </p:pic>
      <p:pic>
        <p:nvPicPr>
          <p:cNvPr id="46" name="Grafik 45">
            <a:extLst>
              <a:ext uri="{FF2B5EF4-FFF2-40B4-BE49-F238E27FC236}">
                <a16:creationId xmlns:a16="http://schemas.microsoft.com/office/drawing/2014/main" id="{5CCF417A-BC9C-47BF-BE7B-770BC162B42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30552" y="5711382"/>
            <a:ext cx="2925064" cy="1484361"/>
          </a:xfrm>
          <a:prstGeom prst="rect">
            <a:avLst/>
          </a:prstGeom>
        </p:spPr>
      </p:pic>
      <p:pic>
        <p:nvPicPr>
          <p:cNvPr id="47" name="Grafik 46">
            <a:extLst>
              <a:ext uri="{FF2B5EF4-FFF2-40B4-BE49-F238E27FC236}">
                <a16:creationId xmlns:a16="http://schemas.microsoft.com/office/drawing/2014/main" id="{44849B08-8B6C-45AF-9B6E-7F7DB058443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31970" y="5709268"/>
            <a:ext cx="2935502" cy="1489658"/>
          </a:xfrm>
          <a:prstGeom prst="rect">
            <a:avLst/>
          </a:prstGeom>
        </p:spPr>
      </p:pic>
      <p:pic>
        <p:nvPicPr>
          <p:cNvPr id="48" name="Grafik 47">
            <a:extLst>
              <a:ext uri="{FF2B5EF4-FFF2-40B4-BE49-F238E27FC236}">
                <a16:creationId xmlns:a16="http://schemas.microsoft.com/office/drawing/2014/main" id="{6611CB40-7858-4C2A-A3C3-4674B5040E4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0102" y="7377701"/>
            <a:ext cx="2935978" cy="1484361"/>
          </a:xfrm>
          <a:prstGeom prst="rect">
            <a:avLst/>
          </a:prstGeom>
        </p:spPr>
      </p:pic>
      <p:pic>
        <p:nvPicPr>
          <p:cNvPr id="49" name="Grafik 48">
            <a:extLst>
              <a:ext uri="{FF2B5EF4-FFF2-40B4-BE49-F238E27FC236}">
                <a16:creationId xmlns:a16="http://schemas.microsoft.com/office/drawing/2014/main" id="{ECC1C6DA-424E-4F3D-9162-7FEBDF5AE70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08684" y="5709268"/>
            <a:ext cx="2925064" cy="1484361"/>
          </a:xfrm>
          <a:prstGeom prst="rect">
            <a:avLst/>
          </a:prstGeom>
        </p:spPr>
      </p:pic>
      <p:pic>
        <p:nvPicPr>
          <p:cNvPr id="50" name="Grafik 49">
            <a:extLst>
              <a:ext uri="{FF2B5EF4-FFF2-40B4-BE49-F238E27FC236}">
                <a16:creationId xmlns:a16="http://schemas.microsoft.com/office/drawing/2014/main" id="{4C87072D-80BB-4FE9-97DB-92C95293E61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0102" y="5707154"/>
            <a:ext cx="2935502" cy="1489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685528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" name="Grafik 39">
            <a:extLst>
              <a:ext uri="{FF2B5EF4-FFF2-40B4-BE49-F238E27FC236}">
                <a16:creationId xmlns:a16="http://schemas.microsoft.com/office/drawing/2014/main" id="{A66D7CA3-7778-4B9B-8C2F-47F4C3B98F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9160" y="738763"/>
            <a:ext cx="2925064" cy="1484361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6F0B706A-AC49-4AB9-8AD3-79A89E1A979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793" y="738763"/>
            <a:ext cx="2935978" cy="1484361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29" name="Grafik 28">
            <a:extLst>
              <a:ext uri="{FF2B5EF4-FFF2-40B4-BE49-F238E27FC236}">
                <a16:creationId xmlns:a16="http://schemas.microsoft.com/office/drawing/2014/main" id="{1DECF78B-1E4A-4D3B-BD46-C7AA3AED704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5793" y="2407195"/>
            <a:ext cx="2935978" cy="1489899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0701AF9E-1CE4-46FB-BABF-E3466D6B2D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14375" y="2407195"/>
            <a:ext cx="2935978" cy="1484361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FAAA0E00-4E42-4376-A379-72095110EB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5793" y="4077984"/>
            <a:ext cx="2935978" cy="1489899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DDB6478A-D803-4E1E-92B8-BD41B9BF7AA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14375" y="4077984"/>
            <a:ext cx="2935978" cy="1489899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id="{6FAC8161-B68B-4761-81CF-C5003DEB0A1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12956" y="7419318"/>
            <a:ext cx="2925064" cy="1484361"/>
          </a:xfrm>
          <a:prstGeom prst="rect">
            <a:avLst/>
          </a:prstGeom>
        </p:spPr>
      </p:pic>
      <p:pic>
        <p:nvPicPr>
          <p:cNvPr id="42" name="Grafik 41">
            <a:extLst>
              <a:ext uri="{FF2B5EF4-FFF2-40B4-BE49-F238E27FC236}">
                <a16:creationId xmlns:a16="http://schemas.microsoft.com/office/drawing/2014/main" id="{1F182EB9-AB58-4200-9695-EA39F6C7F2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4374" y="7419318"/>
            <a:ext cx="2925064" cy="1484361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524C9A87-B6A5-4C35-BFC7-4B309082C776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12956" y="5748773"/>
            <a:ext cx="2935503" cy="1484121"/>
          </a:xfrm>
          <a:prstGeom prst="rect">
            <a:avLst/>
          </a:prstGeom>
        </p:spPr>
      </p:pic>
      <p:pic>
        <p:nvPicPr>
          <p:cNvPr id="44" name="Grafik 43">
            <a:extLst>
              <a:ext uri="{FF2B5EF4-FFF2-40B4-BE49-F238E27FC236}">
                <a16:creationId xmlns:a16="http://schemas.microsoft.com/office/drawing/2014/main" id="{2A519533-73C2-4FF1-A2AB-26095C35CE6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4374" y="5748773"/>
            <a:ext cx="2935503" cy="1489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09252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Grafik 22">
            <a:extLst>
              <a:ext uri="{FF2B5EF4-FFF2-40B4-BE49-F238E27FC236}">
                <a16:creationId xmlns:a16="http://schemas.microsoft.com/office/drawing/2014/main" id="{4BDB50E8-47DA-43D9-BFDF-D3DED1D0F6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935" y="916695"/>
            <a:ext cx="2935978" cy="1484361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4AE7C70C-1047-4BEE-8896-80935709C30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02517" y="916696"/>
            <a:ext cx="2935503" cy="1489658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3F7E45F0-AF29-4814-B945-2A20C14CA1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03935" y="2581943"/>
            <a:ext cx="2935978" cy="1484361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0724F151-8733-4989-A97E-A1EF1B7CB66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2517" y="2576405"/>
            <a:ext cx="2935978" cy="1484361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E0FA5DC7-1D7D-48CA-AFBA-575DB6119A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3935" y="4247190"/>
            <a:ext cx="2935978" cy="1489899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F9C86A6A-D446-4A79-855D-48F7BA4107B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02517" y="4252728"/>
            <a:ext cx="2935978" cy="1489899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39" name="Grafik 38">
            <a:extLst>
              <a:ext uri="{FF2B5EF4-FFF2-40B4-BE49-F238E27FC236}">
                <a16:creationId xmlns:a16="http://schemas.microsoft.com/office/drawing/2014/main" id="{3691A413-4C8E-4181-9092-5B6D25ACED3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03935" y="5929051"/>
            <a:ext cx="2935978" cy="1489899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id="{2A7BFD4F-CDBF-42A6-8693-EEF92B6BEAB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602517" y="5929051"/>
            <a:ext cx="2935978" cy="14898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96518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B52E437D-E5BC-43CE-AC37-E197E768E017}"/>
              </a:ext>
            </a:extLst>
          </p:cNvPr>
          <p:cNvSpPr txBox="1"/>
          <p:nvPr/>
        </p:nvSpPr>
        <p:spPr>
          <a:xfrm>
            <a:off x="2886326" y="314245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ngles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B3C220B5-030C-436F-B2C1-8AAB3D365BE8}"/>
              </a:ext>
            </a:extLst>
          </p:cNvPr>
          <p:cNvSpPr txBox="1"/>
          <p:nvPr/>
        </p:nvSpPr>
        <p:spPr>
          <a:xfrm>
            <a:off x="2886326" y="2496592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Indices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2A36225A-6842-4AAE-ABC3-3F57DE4E15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673" y="917175"/>
            <a:ext cx="2920327" cy="1481957"/>
          </a:xfrm>
          <a:prstGeom prst="rect">
            <a:avLst/>
          </a:prstGeom>
        </p:spPr>
      </p:pic>
      <p:pic>
        <p:nvPicPr>
          <p:cNvPr id="10" name="Grafik 9">
            <a:extLst>
              <a:ext uri="{FF2B5EF4-FFF2-40B4-BE49-F238E27FC236}">
                <a16:creationId xmlns:a16="http://schemas.microsoft.com/office/drawing/2014/main" id="{BF5DFE09-431B-4E50-888B-91B265017CD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5325" y="917175"/>
            <a:ext cx="2920327" cy="1476448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734A8AF8-053F-4E1A-B1ED-691F41EC3FC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2075" y="3086760"/>
            <a:ext cx="2931223" cy="1481957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06D904B2-0EA3-4242-A070-32CE280A430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5325" y="3086760"/>
            <a:ext cx="2920327" cy="1476448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9DD84FB1-0464-4431-8C7A-F759DC558C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075" y="4678940"/>
            <a:ext cx="2920327" cy="1481957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8F1C0EB1-9BCF-4606-926A-4BB8676E236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09876" y="4678941"/>
            <a:ext cx="2931223" cy="1487486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316A810A-CF13-49D0-9DEA-F411103DB22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2075" y="6282160"/>
            <a:ext cx="2920327" cy="1481957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B6C53CB9-6F91-4346-9DD0-0DA16B393846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09876" y="6282161"/>
            <a:ext cx="2931223" cy="1487486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10F123BA-4B68-4948-AAC9-0A4D194C8FA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08673" y="7879852"/>
            <a:ext cx="2920329" cy="1481958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B1F1E9EB-B6B2-4B48-ACBB-032C1B5952F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09876" y="7879853"/>
            <a:ext cx="2920329" cy="14819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9213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>
            <a:extLst>
              <a:ext uri="{FF2B5EF4-FFF2-40B4-BE49-F238E27FC236}">
                <a16:creationId xmlns:a16="http://schemas.microsoft.com/office/drawing/2014/main" id="{9FCCBBBB-5440-4D3A-8D2A-17EEF41429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0954" y="917175"/>
            <a:ext cx="2931223" cy="1481957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3926DFEB-30E1-4CBB-A4D5-C6A2C0CFD5E0}"/>
              </a:ext>
            </a:extLst>
          </p:cNvPr>
          <p:cNvSpPr txBox="1"/>
          <p:nvPr/>
        </p:nvSpPr>
        <p:spPr>
          <a:xfrm>
            <a:off x="-2373315" y="-4856795"/>
            <a:ext cx="22125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200" dirty="0"/>
              <a:t>Figure 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EFE92FA6-2802-4FAD-BC07-BAEA6DA80A54}"/>
              </a:ext>
            </a:extLst>
          </p:cNvPr>
          <p:cNvSpPr txBox="1"/>
          <p:nvPr/>
        </p:nvSpPr>
        <p:spPr>
          <a:xfrm>
            <a:off x="162089" y="76407"/>
            <a:ext cx="2190342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Supplementary Material 1</a:t>
            </a:r>
          </a:p>
        </p:txBody>
      </p:sp>
      <p:pic>
        <p:nvPicPr>
          <p:cNvPr id="23" name="Grafik 22">
            <a:extLst>
              <a:ext uri="{FF2B5EF4-FFF2-40B4-BE49-F238E27FC236}">
                <a16:creationId xmlns:a16="http://schemas.microsoft.com/office/drawing/2014/main" id="{195BF7F9-566B-4B77-AE96-DA217590C4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954" y="2565965"/>
            <a:ext cx="2931223" cy="1481957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4751E109-F8A0-4A13-8D2B-5A0EB409247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02517" y="2565965"/>
            <a:ext cx="2920327" cy="1481957"/>
          </a:xfrm>
          <a:prstGeom prst="rect">
            <a:avLst/>
          </a:prstGeom>
        </p:spPr>
      </p:pic>
      <p:pic>
        <p:nvPicPr>
          <p:cNvPr id="27" name="Grafik 26">
            <a:extLst>
              <a:ext uri="{FF2B5EF4-FFF2-40B4-BE49-F238E27FC236}">
                <a16:creationId xmlns:a16="http://schemas.microsoft.com/office/drawing/2014/main" id="{54DA408C-EDED-4DDF-A836-28F954DC989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0954" y="4214755"/>
            <a:ext cx="2918046" cy="1480799"/>
          </a:xfrm>
          <a:prstGeom prst="rect">
            <a:avLst/>
          </a:prstGeom>
        </p:spPr>
      </p:pic>
      <p:pic>
        <p:nvPicPr>
          <p:cNvPr id="29" name="Grafik 28">
            <a:extLst>
              <a:ext uri="{FF2B5EF4-FFF2-40B4-BE49-F238E27FC236}">
                <a16:creationId xmlns:a16="http://schemas.microsoft.com/office/drawing/2014/main" id="{99C35436-A193-4988-957C-FF926CF72DD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02517" y="4214755"/>
            <a:ext cx="2928933" cy="1480799"/>
          </a:xfrm>
          <a:prstGeom prst="rect">
            <a:avLst/>
          </a:prstGeom>
        </p:spPr>
      </p:pic>
      <p:pic>
        <p:nvPicPr>
          <p:cNvPr id="31" name="Grafik 30">
            <a:extLst>
              <a:ext uri="{FF2B5EF4-FFF2-40B4-BE49-F238E27FC236}">
                <a16:creationId xmlns:a16="http://schemas.microsoft.com/office/drawing/2014/main" id="{49EE8001-45D9-4275-A1A2-2BA290B76B2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10954" y="5858079"/>
            <a:ext cx="2918046" cy="1480799"/>
          </a:xfrm>
          <a:prstGeom prst="rect">
            <a:avLst/>
          </a:prstGeom>
        </p:spPr>
      </p:pic>
      <p:pic>
        <p:nvPicPr>
          <p:cNvPr id="33" name="Grafik 32">
            <a:extLst>
              <a:ext uri="{FF2B5EF4-FFF2-40B4-BE49-F238E27FC236}">
                <a16:creationId xmlns:a16="http://schemas.microsoft.com/office/drawing/2014/main" id="{D843318F-FC97-45CB-9F19-9DEEB165A42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602517" y="5858080"/>
            <a:ext cx="2928933" cy="1486324"/>
          </a:xfrm>
          <a:prstGeom prst="rect">
            <a:avLst/>
          </a:prstGeom>
        </p:spPr>
      </p:pic>
      <p:pic>
        <p:nvPicPr>
          <p:cNvPr id="35" name="Grafik 34">
            <a:extLst>
              <a:ext uri="{FF2B5EF4-FFF2-40B4-BE49-F238E27FC236}">
                <a16:creationId xmlns:a16="http://schemas.microsoft.com/office/drawing/2014/main" id="{F469ED87-5606-4D4A-B3C1-8AFE012E08D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0954" y="7501404"/>
            <a:ext cx="2931096" cy="1487422"/>
          </a:xfrm>
          <a:prstGeom prst="rect">
            <a:avLst/>
          </a:prstGeom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B9B32CB4-3EEF-4288-BF3F-3B87EFD4A12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02517" y="7501404"/>
            <a:ext cx="2928933" cy="1480799"/>
          </a:xfrm>
          <a:prstGeom prst="rect">
            <a:avLst/>
          </a:prstGeom>
        </p:spPr>
      </p:pic>
      <p:pic>
        <p:nvPicPr>
          <p:cNvPr id="3" name="Grafik 2">
            <a:extLst>
              <a:ext uri="{FF2B5EF4-FFF2-40B4-BE49-F238E27FC236}">
                <a16:creationId xmlns:a16="http://schemas.microsoft.com/office/drawing/2014/main" id="{B066850E-73C5-48FE-BBF8-97785074811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31342" y="911710"/>
            <a:ext cx="2900108" cy="1487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37635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-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Office PowerPoint</Application>
  <PresentationFormat>A4-Papier (210 x 297 mm)</PresentationFormat>
  <Paragraphs>22</Paragraphs>
  <Slides>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1_Office-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nuel Weber</dc:creator>
  <cp:lastModifiedBy>Olmos, Manuel</cp:lastModifiedBy>
  <cp:revision>290</cp:revision>
  <cp:lastPrinted>2023-02-13T11:04:56Z</cp:lastPrinted>
  <dcterms:created xsi:type="dcterms:W3CDTF">2015-10-11T16:58:51Z</dcterms:created>
  <dcterms:modified xsi:type="dcterms:W3CDTF">2025-05-22T05:23:57Z</dcterms:modified>
</cp:coreProperties>
</file>